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772400" cy="100584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219458-AF4C-45CE-BB5E-D0372AB8381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480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88800" y="2346120"/>
            <a:ext cx="699480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88800" y="5814000"/>
            <a:ext cx="699480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AE9D14-A1F4-4283-8946-07585496A16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480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88800" y="2346120"/>
            <a:ext cx="34131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972960" y="2346120"/>
            <a:ext cx="34131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88800" y="5814000"/>
            <a:ext cx="34131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972960" y="5814000"/>
            <a:ext cx="34131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524104-5093-41E0-A0A8-13F5A146DB4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480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88800" y="2346120"/>
            <a:ext cx="22521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754000" y="2346120"/>
            <a:ext cx="22521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119200" y="2346120"/>
            <a:ext cx="22521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88800" y="5814000"/>
            <a:ext cx="22521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754000" y="5814000"/>
            <a:ext cx="22521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119200" y="5814000"/>
            <a:ext cx="22521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92FAF7-0D9E-4773-BF24-C44F201A670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480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88800" y="2346120"/>
            <a:ext cx="6994800" cy="6638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9B0DC4-C17E-4C49-A633-EED5E80F7F3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480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88800" y="2346120"/>
            <a:ext cx="6994800" cy="6638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961E3D-3AF1-4DA4-A075-8CA155F9C1A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480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88800" y="2346120"/>
            <a:ext cx="3413160" cy="6638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972960" y="2346120"/>
            <a:ext cx="3413160" cy="6638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DCD4AF-D461-44CF-9294-7553404521E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480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DF9A0B-E51F-4017-8B6D-BEEF54E3A34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88800" y="402840"/>
            <a:ext cx="6994800" cy="7772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462B76-5523-4F68-93B2-EE6A947AC91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480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88800" y="2346120"/>
            <a:ext cx="34131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972960" y="2346120"/>
            <a:ext cx="3413160" cy="6638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88800" y="5814000"/>
            <a:ext cx="34131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CD3D00-9932-41A4-B0A5-D3A51EF80A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480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88800" y="2346120"/>
            <a:ext cx="3413160" cy="6638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972960" y="2346120"/>
            <a:ext cx="34131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972960" y="5814000"/>
            <a:ext cx="34131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A4E24B-D6CE-4C86-BBA4-947C71DCE70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480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88800" y="2346120"/>
            <a:ext cx="34131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972960" y="2346120"/>
            <a:ext cx="34131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88800" y="5814000"/>
            <a:ext cx="699480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0B6A21-5002-4F6C-AEE8-8ADE062A0D8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480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88800" y="2346120"/>
            <a:ext cx="6994800" cy="6638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88800" y="9159840"/>
            <a:ext cx="1812960" cy="698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655720" y="9159840"/>
            <a:ext cx="2460960" cy="698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570640" y="9159840"/>
            <a:ext cx="1812960" cy="698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1E1525B-F56A-477D-B506-DF559F982B6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Ct-A" descr=""/>
          <p:cNvPicPr/>
          <p:nvPr/>
        </p:nvPicPr>
        <p:blipFill>
          <a:blip r:embed="rId1"/>
          <a:srcRect l="3576" t="3576" r="3272" b="3272"/>
          <a:stretch/>
        </p:blipFill>
        <p:spPr>
          <a:xfrm>
            <a:off x="304920" y="838080"/>
            <a:ext cx="3135240" cy="313560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847080" y="380880"/>
            <a:ext cx="2012400" cy="405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ample A Ave C</a:t>
            </a:r>
            <a:r>
              <a:rPr b="1" lang="en-US" sz="1800" spc="-1" strike="noStrike" baseline="-25000">
                <a:solidFill>
                  <a:srgbClr val="000000"/>
                </a:solidFill>
                <a:latin typeface="Arial"/>
              </a:rPr>
              <a:t>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383040" y="30492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76320" y="0"/>
            <a:ext cx="1886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dditional file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Ct-B" descr=""/>
          <p:cNvPicPr/>
          <p:nvPr/>
        </p:nvPicPr>
        <p:blipFill>
          <a:blip r:embed="rId2"/>
          <a:srcRect l="3272" t="3576" r="3576" b="3272"/>
          <a:stretch/>
        </p:blipFill>
        <p:spPr>
          <a:xfrm>
            <a:off x="4255920" y="826920"/>
            <a:ext cx="3135600" cy="3135600"/>
          </a:xfrm>
          <a:prstGeom prst="rect">
            <a:avLst/>
          </a:prstGeom>
          <a:ln w="0">
            <a:noFill/>
          </a:ln>
        </p:spPr>
      </p:pic>
      <p:sp>
        <p:nvSpPr>
          <p:cNvPr id="46" name=""/>
          <p:cNvSpPr/>
          <p:nvPr/>
        </p:nvSpPr>
        <p:spPr>
          <a:xfrm>
            <a:off x="4809600" y="380880"/>
            <a:ext cx="2012400" cy="405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ample B Ave C</a:t>
            </a:r>
            <a:r>
              <a:rPr b="1" lang="en-US" sz="1800" spc="-1" strike="noStrike" baseline="-25000">
                <a:solidFill>
                  <a:srgbClr val="000000"/>
                </a:solidFill>
                <a:latin typeface="Arial"/>
              </a:rPr>
              <a:t>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3835800" y="30492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" name="FC_log2" descr=""/>
          <p:cNvPicPr/>
          <p:nvPr/>
        </p:nvPicPr>
        <p:blipFill>
          <a:blip r:embed="rId3"/>
          <a:srcRect l="3576" t="3576" r="3272" b="3272"/>
          <a:stretch/>
        </p:blipFill>
        <p:spPr>
          <a:xfrm>
            <a:off x="304920" y="5638680"/>
            <a:ext cx="3135240" cy="3135600"/>
          </a:xfrm>
          <a:prstGeom prst="rect">
            <a:avLst/>
          </a:prstGeom>
          <a:ln w="0">
            <a:noFill/>
          </a:ln>
        </p:spPr>
      </p:pic>
      <p:sp>
        <p:nvSpPr>
          <p:cNvPr id="49" name=""/>
          <p:cNvSpPr/>
          <p:nvPr/>
        </p:nvSpPr>
        <p:spPr>
          <a:xfrm>
            <a:off x="701280" y="5348160"/>
            <a:ext cx="2723040" cy="405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/A Fold Change (log</a:t>
            </a:r>
            <a:r>
              <a:rPr b="1" lang="en-US" sz="18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295920" y="525780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1" name=""/>
          <p:cNvGraphicFramePr/>
          <p:nvPr/>
        </p:nvGraphicFramePr>
        <p:xfrm>
          <a:off x="304920" y="4114800"/>
          <a:ext cx="3200400" cy="1143000"/>
        </p:xfrm>
        <a:graphic>
          <a:graphicData uri="http://schemas.openxmlformats.org/drawingml/2006/table">
            <a:tbl>
              <a:tblPr/>
              <a:tblGrid>
                <a:gridCol w="865080"/>
                <a:gridCol w="733320"/>
                <a:gridCol w="824040"/>
                <a:gridCol w="777960"/>
              </a:tblGrid>
              <a:tr h="457200">
                <a:tc>
                  <a:txBody>
                    <a:bodyPr lIns="90000" rIns="90000" tIns="0" bIns="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hermal Cycler Mode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0" bIns="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BI 75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0" bIns="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x3000P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0" bIns="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Cycler iQ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3000">
                <a:tc>
                  <a:txBody>
                    <a:bodyPr lIns="90000" rIns="90000" tIns="0" bIns="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BI 75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0" bIns="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0" bIns="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0" bIns="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00160">
                <a:tc>
                  <a:txBody>
                    <a:bodyPr lIns="90000" rIns="90000" tIns="0" bIns="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x3000P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0" bIns="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9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0" bIns="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0" bIns="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2640">
                <a:tc>
                  <a:txBody>
                    <a:bodyPr lIns="90000" rIns="90000" tIns="0" bIns="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Cycler iQ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0" bIns="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9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0" bIns="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9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0" bIns="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52" name=""/>
          <p:cNvGraphicFramePr/>
          <p:nvPr/>
        </p:nvGraphicFramePr>
        <p:xfrm>
          <a:off x="4191120" y="4114800"/>
          <a:ext cx="3200400" cy="1143000"/>
        </p:xfrm>
        <a:graphic>
          <a:graphicData uri="http://schemas.openxmlformats.org/drawingml/2006/table">
            <a:tbl>
              <a:tblPr/>
              <a:tblGrid>
                <a:gridCol w="865080"/>
                <a:gridCol w="733320"/>
                <a:gridCol w="824040"/>
                <a:gridCol w="777960"/>
              </a:tblGrid>
              <a:tr h="457200">
                <a:tc>
                  <a:txBody>
                    <a:bodyPr lIns="90000" rIns="90000" tIns="0" bIns="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hermal Cycler Mode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0" bIns="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BI 75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0" bIns="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x3000P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0" bIns="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Cycler iQ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3000">
                <a:tc>
                  <a:txBody>
                    <a:bodyPr lIns="90000" rIns="90000" tIns="0" bIns="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BI 75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0" bIns="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0" bIns="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0" bIns="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00160">
                <a:tc>
                  <a:txBody>
                    <a:bodyPr lIns="90000" rIns="90000" tIns="0" bIns="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x3000P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0" bIns="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9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0" bIns="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0" bIns="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2640">
                <a:tc>
                  <a:txBody>
                    <a:bodyPr lIns="90000" rIns="90000" tIns="0" bIns="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Cycler iQ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0" bIns="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9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0" bIns="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8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0" bIns="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53" name=""/>
          <p:cNvGraphicFramePr/>
          <p:nvPr/>
        </p:nvGraphicFramePr>
        <p:xfrm>
          <a:off x="304920" y="8839080"/>
          <a:ext cx="3200400" cy="1143000"/>
        </p:xfrm>
        <a:graphic>
          <a:graphicData uri="http://schemas.openxmlformats.org/drawingml/2006/table">
            <a:tbl>
              <a:tblPr/>
              <a:tblGrid>
                <a:gridCol w="865080"/>
                <a:gridCol w="733320"/>
                <a:gridCol w="824040"/>
                <a:gridCol w="777960"/>
              </a:tblGrid>
              <a:tr h="457200">
                <a:tc>
                  <a:txBody>
                    <a:bodyPr lIns="90000" rIns="90000" tIns="0" bIns="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hermal Cycler Mode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0" bIns="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BI 75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0" bIns="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x3000P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0" bIns="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Cycler iQ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3000">
                <a:tc>
                  <a:txBody>
                    <a:bodyPr lIns="90000" rIns="90000" tIns="0" bIns="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BI 75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0" bIns="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0" bIns="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0" bIns="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00160">
                <a:tc>
                  <a:txBody>
                    <a:bodyPr lIns="90000" rIns="90000" tIns="0" bIns="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x3000P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0" bIns="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7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0" bIns="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0" bIns="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2640">
                <a:tc>
                  <a:txBody>
                    <a:bodyPr lIns="90000" rIns="90000" tIns="0" bIns="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Cycler iQ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0" bIns="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9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0" bIns="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7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0" bIns="0" anchor="ctr" anchorCtr="1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54" name=""/>
          <p:cNvSpPr/>
          <p:nvPr/>
        </p:nvSpPr>
        <p:spPr>
          <a:xfrm>
            <a:off x="3581280" y="5638680"/>
            <a:ext cx="3810240" cy="324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orrelations between different real-time PCR instruments for the raw C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Arial"/>
              </a:rPr>
              <a:t>T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values and fold-change results between the two MAQC reference RNA samples analyzed on the Human Drug Metabolism RT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rofiler™ PCR array (APH-002). Five replicate arrays were run for each sample on each of the three instruments: ABI 7500 Real-Time PCR System or Stratagene Mx3000P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TM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using SuperArray’s RT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SYBR Green/ROX qPCR Master Mix (Cat# PA-012), or BioRad iCycler iQ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TM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using RT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SYBR Green/Fluorescein qPCR Master Mix (Cat# PA-011).  The average C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Arial"/>
              </a:rPr>
              <a:t>T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value for each assay is compared in panels A and B.  The results show a high correlation across instruments at the level of measurement values.  Panel C shows the cross-thermocycler comparison of fold change results obtained from these data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4-30T15:26:47Z</dcterms:created>
  <dc:creator> </dc:creator>
  <dc:description/>
  <dc:language>en-US</dc:language>
  <cp:lastModifiedBy> </cp:lastModifiedBy>
  <dcterms:modified xsi:type="dcterms:W3CDTF">2008-07-02T19:37:34Z</dcterms:modified>
  <cp:revision>14</cp:revision>
  <dc:subject/>
  <dc:title>Slide 1</dc:title>
</cp:coreProperties>
</file>